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3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8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76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D398A0-8FB0-4524-ACDC-FFECE8A6D20A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5E8EF8-11A7-4C1E-AC4D-35294FC13E6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81729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6">
            <a:extLst>
              <a:ext uri="{FF2B5EF4-FFF2-40B4-BE49-F238E27FC236}">
                <a16:creationId xmlns:a16="http://schemas.microsoft.com/office/drawing/2014/main" id="{E5E2E853-D007-ECD7-4250-D141757C99E1}"/>
              </a:ext>
            </a:extLst>
          </p:cNvPr>
          <p:cNvSpPr txBox="1"/>
          <p:nvPr/>
        </p:nvSpPr>
        <p:spPr>
          <a:xfrm>
            <a:off x="4399196" y="9555480"/>
            <a:ext cx="3372837" cy="502563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0" tIns="0" rIns="0" bIns="0" anchor="b" anchorCtr="0" compatLnSpc="1">
            <a:noAutofit/>
          </a:bodyPr>
          <a:lstStyle/>
          <a:p>
            <a:pPr marL="0" marR="0" lvl="0" indent="0" algn="r" defTabSz="914400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EB40A887-6B93-42C4-AED2-C65EF5D2682A}" type="slidenum">
              <a:t>1</a:t>
            </a:fld>
            <a:endParaRPr lang="de-DE" sz="1400" b="0" i="0" u="none" strike="noStrike" kern="1200" cap="none" spc="0" baseline="0">
              <a:solidFill>
                <a:srgbClr val="000000"/>
              </a:solidFill>
              <a:uFillTx/>
              <a:latin typeface="Liberation Serif" pitchFamily="18"/>
              <a:ea typeface="DejaVu Sans" pitchFamily="2"/>
              <a:cs typeface="Noto Sans" pitchFamily="2"/>
            </a:endParaRPr>
          </a:p>
        </p:txBody>
      </p:sp>
      <p:sp>
        <p:nvSpPr>
          <p:cNvPr id="3" name="Slide Image Placeholder 1">
            <a:extLst>
              <a:ext uri="{FF2B5EF4-FFF2-40B4-BE49-F238E27FC236}">
                <a16:creationId xmlns:a16="http://schemas.microsoft.com/office/drawing/2014/main" id="{4A674B9A-36A2-D86D-12F8-04B9E17E38E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533396" y="763588"/>
            <a:ext cx="6704015" cy="3771899"/>
          </a:xfrm>
          <a:solidFill>
            <a:srgbClr val="729FCF"/>
          </a:solidFill>
          <a:ln w="25402">
            <a:solidFill>
              <a:srgbClr val="3465A4"/>
            </a:solidFill>
            <a:prstDash val="solid"/>
          </a:ln>
        </p:spPr>
      </p:sp>
      <p:sp>
        <p:nvSpPr>
          <p:cNvPr id="4" name="Notes Placeholder 2">
            <a:extLst>
              <a:ext uri="{FF2B5EF4-FFF2-40B4-BE49-F238E27FC236}">
                <a16:creationId xmlns:a16="http://schemas.microsoft.com/office/drawing/2014/main" id="{217A186C-C3D2-F7D6-B963-A01A9265236E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de-DE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C5AEF0-4E91-955D-3374-E9FB7DB997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236F10-8F8E-CFDE-74B3-E3A0BC9FB9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A25B74-48B3-BCBA-B0CC-3B1F5FD58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B6722-5B08-EB3B-296B-D8C1B490B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DA3E21-C424-E0E2-B5CF-D47D53846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527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C7DAA-254E-DE5F-DF99-981B5FB5ED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B1EE64-895B-FA96-A12A-8D323DF2D8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1F3EB-3DCF-5614-7EB5-FE3338866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D161D6-A924-AE4E-33C8-27EB92C09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1E1A88-E1EE-C983-F9C7-2125CCA42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9837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F248F5-B5DB-E763-9DC1-07E86D02B2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B70677-60A6-2A63-D367-BDAC7C93C7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4225D0-C6A6-3D7E-C726-8152F1EF9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75BEC8-CC6B-8F64-463B-925FD2793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7D084A-521F-087C-0E6E-C227C5ED6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6376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B1328-E0F8-5A17-2EF9-398DFC4FE2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E51873-BF58-7359-60CB-2251F29140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99213D-08C8-7D40-F779-71A42869C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29068-C5EB-33A5-59EE-4D6DCBA94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A83C2-0498-0A9F-94A5-F7ABF8499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8973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FEF1D8-3D84-CD42-DB13-3313F2DEF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9C0CF0-8B8F-F315-FD39-3AC3B009CF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3F0AF-4D3C-C4EA-E222-4E2E147DE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0DCE0E-218B-9D4C-19DB-32262618C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815197-58E8-D7FE-D5F4-72D7FA541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546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F9ABA-B924-EA51-E13E-94632C249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A1C654-D954-E97A-4400-81EBE857AA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39A709-2378-B560-6AF9-49C540270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DB53DF-F52B-8E1A-73F4-09F254B04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E9D91C-04F7-9C22-ADDF-011DC0557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65439A-0CF0-9C8B-5EF4-851A25E32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5005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8F5E1-6451-24B9-961F-8FAA13902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5B8214-9371-3189-7D02-DF10B3922B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71AD5B-74BE-785F-19FC-6A9D695720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22CEB35-6551-442F-78FC-A95DE18135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62A398-D995-0794-2BE9-5F54297CC3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137FF0-F16C-6DB5-57C9-F5CAAAB23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0C70CB-FE88-07A6-CA25-4AE1C8820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7C20B7-547A-C3AD-6BBF-E512F87EF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5806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25D8F-75CD-5A14-37F8-FF2582688E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39A414-4684-DAEB-AFA1-C801DEEBF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8B5313-B5A2-4D76-D7A6-9C7F493D9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C1D149-5F06-46C0-2C19-CB2B33AA4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7749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3ABDB2-6C97-95E4-826F-E2CCDCBEF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26710F-6C20-BAA5-D0C6-0344E32D8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EA6DF0-DD5B-12C0-7ECB-E3FF1C933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6666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BCD71-0CD2-BE47-CC2D-73C994CC5F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126DA8-CA1E-79F3-B9C2-1785F35089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D0A606-4F63-B103-BA49-92474C808F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27903B-2D5E-B6C3-B49D-D7E07D6C9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9765F7-9182-C50B-57CA-EA973FFC4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BD071C-78B6-F814-4055-E3F5A2BF3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1573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12DF4E-FDE9-6B77-DB16-23B5A167F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D057CF-D219-A2F8-7456-21ABE312D4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D87049-5996-4CF9-F27A-38749F78B5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D81060-9BA3-CE81-3091-A70E509A5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6169D2-015F-9FC6-6747-E17ABBFEE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9ADD80-FAB7-9111-CBFF-6DE82737F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2841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F4DFA27-75D0-FE5A-6F4E-F1D843E21B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0CC1DB-2355-0326-3A2D-65F94608A7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76F02F-76D8-4E0E-0158-2FF64F3CCE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DB02508-7933-4EC5-A1A1-5784438D8CE8}" type="datetimeFigureOut">
              <a:rPr lang="de-DE" smtClean="0"/>
              <a:t>27.04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B6A681-D005-F558-04AD-532095FE6E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4D797-C056-E9B2-BB3B-08EF221779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F840CF-FBC1-4675-82A1-AF0FB4F87E7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188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5" descr="A graph of a number of percents&#10;&#10;Description automatically generated with medium confidence">
            <a:extLst>
              <a:ext uri="{FF2B5EF4-FFF2-40B4-BE49-F238E27FC236}">
                <a16:creationId xmlns:a16="http://schemas.microsoft.com/office/drawing/2014/main" id="{19AB790B-B7EE-EC1C-2E3C-D732071229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9707" y="1636373"/>
            <a:ext cx="6000323" cy="3585255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3" name="Picture 27" descr="A water drop with a percent symbol&#10;&#10;Description automatically generated">
            <a:extLst>
              <a:ext uri="{FF2B5EF4-FFF2-40B4-BE49-F238E27FC236}">
                <a16:creationId xmlns:a16="http://schemas.microsoft.com/office/drawing/2014/main" id="{C2BBAEDE-24CD-AED1-8AAF-80179B8069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64226" y="1442666"/>
            <a:ext cx="4224211" cy="4716572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4" name="Picture 29" descr="A screenshot of a video game&#10;&#10;Description automatically generated">
            <a:extLst>
              <a:ext uri="{FF2B5EF4-FFF2-40B4-BE49-F238E27FC236}">
                <a16:creationId xmlns:a16="http://schemas.microsoft.com/office/drawing/2014/main" id="{BABE0876-CBE4-5D4F-43D5-EBBDB13BD8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07849" y="-147103"/>
            <a:ext cx="3675794" cy="5562439"/>
          </a:xfrm>
          <a:prstGeom prst="rect">
            <a:avLst/>
          </a:prstGeom>
          <a:noFill/>
          <a:ln cap="flat"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4">
            <a:extLst>
              <a:ext uri="{FF2B5EF4-FFF2-40B4-BE49-F238E27FC236}">
                <a16:creationId xmlns:a16="http://schemas.microsoft.com/office/drawing/2014/main" id="{1DCC45C6-0D28-5A3A-14BB-E215C0A3FA93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5184032" y="986843"/>
            <a:ext cx="6170662" cy="4874714"/>
          </a:xfrm>
        </p:spPr>
        <p:txBody>
          <a:bodyPr/>
          <a:lstStyle/>
          <a:p>
            <a:r>
              <a:rPr lang="en-US" sz="18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3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– Meteorological days: This figure shows the four cohort dividers. Summer days, Frost days, High humidity days (R90) and the days with the biggest difference from the local monthly 10-year mean air temperature (G10). Summer days were defined as days when the air temperature reaches &gt;= 25 °C, while frost days were defined when the air temperature reaches ≤ 0 °C. High humidity days were defined as days when the mean of the relative air humidity was &gt; 90%. The G10 cohort ranked the temperature differences on a case-by-case basis (e.g., April 2019 - mean April), 10% of the upper (TX) and lower values (TN) were used as cohort dividers.</a:t>
            </a:r>
            <a:endParaRPr lang="de-DE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  <p:sp>
        <p:nvSpPr>
          <p:cNvPr id="4" name="Text Placeholder 5">
            <a:extLst>
              <a:ext uri="{FF2B5EF4-FFF2-40B4-BE49-F238E27FC236}">
                <a16:creationId xmlns:a16="http://schemas.microsoft.com/office/drawing/2014/main" id="{59680908-72ED-1598-C5D1-0F2A74CFC25F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9223" y="2058165"/>
            <a:ext cx="3932027" cy="3811065"/>
          </a:xfrm>
        </p:spPr>
        <p:txBody>
          <a:bodyPr/>
          <a:lstStyle/>
          <a:p>
            <a:endParaRPr lang="de-DE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D89E2553-9C22-8FF1-C96F-444D41AA6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8433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</Words>
  <Application>Microsoft Office PowerPoint</Application>
  <PresentationFormat>Widescreen</PresentationFormat>
  <Paragraphs>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Liberation Serif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 Burger</dc:creator>
  <cp:lastModifiedBy>M Burger</cp:lastModifiedBy>
  <cp:revision>2</cp:revision>
  <dcterms:created xsi:type="dcterms:W3CDTF">2024-04-27T09:54:00Z</dcterms:created>
  <dcterms:modified xsi:type="dcterms:W3CDTF">2024-04-27T10:14:02Z</dcterms:modified>
</cp:coreProperties>
</file>